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525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A3FC78-667E-4F71-B483-0EDFE0DCBD5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714240" y="609120"/>
            <a:ext cx="8096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714240" y="1981080"/>
            <a:ext cx="8096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714240" y="4130640"/>
            <a:ext cx="8096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F96C63-3D02-47CB-B2FE-5F40866BC5D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714240" y="609120"/>
            <a:ext cx="8096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714240" y="1981080"/>
            <a:ext cx="39510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863240" y="1981080"/>
            <a:ext cx="39510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714240" y="4130640"/>
            <a:ext cx="39510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863240" y="4130640"/>
            <a:ext cx="39510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60A924-2660-46D7-92A2-29A58AF91ED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714240" y="609120"/>
            <a:ext cx="8096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714240" y="1981080"/>
            <a:ext cx="26067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451680" y="1981080"/>
            <a:ext cx="26067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189120" y="1981080"/>
            <a:ext cx="26067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714240" y="4130640"/>
            <a:ext cx="26067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451680" y="4130640"/>
            <a:ext cx="26067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189120" y="4130640"/>
            <a:ext cx="26067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54D564-A1C0-4F31-8DBA-27AA1B7DD2E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714240" y="609120"/>
            <a:ext cx="8096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714240" y="1981080"/>
            <a:ext cx="809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AA5B8A-524A-4007-A056-40C14D7DA5C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714240" y="609120"/>
            <a:ext cx="8096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714240" y="1981080"/>
            <a:ext cx="809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F53B97-913E-4918-AA9A-AAB4922D14C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714240" y="609120"/>
            <a:ext cx="8096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714240" y="1981080"/>
            <a:ext cx="39510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863240" y="1981080"/>
            <a:ext cx="39510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2476B7-0CDC-4287-BA5A-944A7E21D34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714240" y="609120"/>
            <a:ext cx="8096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F47616-FC29-4EBF-AF41-A8C6EFB8E16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714240" y="609120"/>
            <a:ext cx="8096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F2EDC6-A2B4-4BDD-87BC-AE05DA2C233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714240" y="609120"/>
            <a:ext cx="8096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714240" y="1981080"/>
            <a:ext cx="39510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863240" y="1981080"/>
            <a:ext cx="39510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714240" y="4130640"/>
            <a:ext cx="39510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0BE223-0F4C-4922-ABC4-AB943F31956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714240" y="609120"/>
            <a:ext cx="8096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714240" y="1981080"/>
            <a:ext cx="39510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863240" y="1981080"/>
            <a:ext cx="39510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863240" y="4130640"/>
            <a:ext cx="39510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CED8C8-F795-4FEB-A46C-B8C5031D292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714240" y="609120"/>
            <a:ext cx="8096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714240" y="1981080"/>
            <a:ext cx="39510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863240" y="1981080"/>
            <a:ext cx="39510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714240" y="4130640"/>
            <a:ext cx="8096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3E12E5-7855-4E81-8A09-328D3EA8CB4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714240" y="609120"/>
            <a:ext cx="8096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714240" y="1981080"/>
            <a:ext cx="809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713880" y="6248520"/>
            <a:ext cx="198468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254400" y="6248520"/>
            <a:ext cx="301608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826320" y="6248520"/>
            <a:ext cx="19843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26607DA-CB61-4A17-8728-B780DBE0FF18}" type="slidenum">
              <a:rPr b="0" lang="it-IT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3"/>
          <p:cNvSpPr/>
          <p:nvPr/>
        </p:nvSpPr>
        <p:spPr>
          <a:xfrm>
            <a:off x="154080" y="706320"/>
            <a:ext cx="8929440" cy="213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57200" indent="-457200"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Times New Roman"/>
              </a:rPr>
              <a:t>GENERAL INCLUSION CRITERIA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 lvl="1" marL="914400" indent="-457200">
              <a:lnSpc>
                <a:spcPct val="100000"/>
              </a:lnSpc>
              <a:buClr>
                <a:srgbClr val="000000"/>
              </a:buClr>
              <a:buFont typeface="Times New Roman"/>
              <a:buChar char="•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Clinical diagnosis of schizophrenia  (guided by DSM-IV criteria).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 lvl="1" marL="914400" indent="-457200">
              <a:lnSpc>
                <a:spcPct val="100000"/>
              </a:lnSpc>
              <a:buClr>
                <a:srgbClr val="000000"/>
              </a:buClr>
              <a:buFont typeface="Times New Roman"/>
              <a:buChar char="•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Treatment with clozapine for at least six months at a stable dose of 400 mg or more per day, or lower doses if severe dose-limiting side-effects.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 lvl="1" marL="914400" indent="-457200">
              <a:lnSpc>
                <a:spcPct val="100000"/>
              </a:lnSpc>
              <a:buClr>
                <a:srgbClr val="000000"/>
              </a:buClr>
              <a:buFont typeface="Times New Roman"/>
              <a:buChar char="•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Unsatisfactory benefit from clozapine treatment, as indicated by the presence of positive symptoms (delusions, hallucinations, </a:t>
            </a:r>
            <a:r>
              <a:rPr b="0" lang="it-IT" sz="1400" spc="-1" strike="noStrike">
                <a:solidFill>
                  <a:srgbClr val="000000"/>
                </a:solidFill>
                <a:latin typeface="Times New Roman"/>
              </a:rPr>
              <a:t>disorganised 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speech or behaviour) 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 lvl="1" marL="914400" indent="-457200">
              <a:lnSpc>
                <a:spcPct val="100000"/>
              </a:lnSpc>
              <a:buClr>
                <a:srgbClr val="000000"/>
              </a:buClr>
              <a:buFont typeface="Times New Roman"/>
              <a:buChar char="•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Age 18 years and above.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 lvl="1" marL="914400" indent="-457200">
              <a:lnSpc>
                <a:spcPct val="100000"/>
              </a:lnSpc>
              <a:buClr>
                <a:srgbClr val="000000"/>
              </a:buClr>
              <a:buFont typeface="Times New Roman"/>
              <a:buChar char="•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Agreement between investigator and patient to enter the study (ability to give informed consent).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 lvl="1" marL="914400" indent="-457200">
              <a:lnSpc>
                <a:spcPct val="100000"/>
              </a:lnSpc>
              <a:buClr>
                <a:srgbClr val="000000"/>
              </a:buClr>
              <a:buFont typeface="Times New Roman"/>
              <a:buChar char="•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The patient is resident in Italy.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Text Box 4"/>
          <p:cNvSpPr/>
          <p:nvPr/>
        </p:nvSpPr>
        <p:spPr>
          <a:xfrm>
            <a:off x="457200" y="4551480"/>
            <a:ext cx="8626320" cy="201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57200" indent="-457200"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Times New Roman"/>
              </a:rPr>
              <a:t>ADDITIONAL INCLUSION CRITERIA FOR RANDOM ALLOCATION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Patients fulfilling all six inclusion criteria, and all the following criteria, will be included in the randomised cohort: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Times New Roman"/>
            </a:endParaRPr>
          </a:p>
          <a:p>
            <a:pPr lvl="1" marL="914400" indent="-457200">
              <a:lnSpc>
                <a:spcPct val="100000"/>
              </a:lnSpc>
              <a:buClr>
                <a:srgbClr val="000000"/>
              </a:buClr>
              <a:buFont typeface="Times New Roman"/>
              <a:buAutoNum type="arabicParenR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It is considered clinically reasonable to try combination treatment with clozapine and aripiprazole or with clozapine and haloperidol. 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 lvl="1" marL="914400" indent="-457200">
              <a:lnSpc>
                <a:spcPct val="100000"/>
              </a:lnSpc>
              <a:buClr>
                <a:srgbClr val="000000"/>
              </a:buClr>
              <a:buFont typeface="Times New Roman"/>
              <a:buAutoNum type="arabicParenR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Uncertainty about which trial treatment would be best for the participant.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 lvl="1" marL="914400" indent="-457200">
              <a:lnSpc>
                <a:spcPct val="100000"/>
              </a:lnSpc>
              <a:buClr>
                <a:srgbClr val="000000"/>
              </a:buClr>
              <a:buFont typeface="Times New Roman"/>
              <a:buAutoNum type="arabicParenR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No medical disorder or condition contraindicates either of the investigational drugs. 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 lvl="1" marL="914400" indent="-457200">
              <a:lnSpc>
                <a:spcPct val="100000"/>
              </a:lnSpc>
              <a:buClr>
                <a:srgbClr val="000000"/>
              </a:buClr>
              <a:buFont typeface="Times New Roman"/>
              <a:buAutoNum type="arabicParenR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Agreement between investigator and patient to discontinue any antipsychotic drugs other than clozapine (including long-acting antipsychotic drugs). 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Text Box 5"/>
          <p:cNvSpPr/>
          <p:nvPr/>
        </p:nvSpPr>
        <p:spPr>
          <a:xfrm>
            <a:off x="2517840" y="3262320"/>
            <a:ext cx="6565680" cy="1068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Times New Roman"/>
              </a:rPr>
              <a:t>CRITERIA FOR INCLUSION IN THE OBSERVATIONAL COHORT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Patients fulfilling all six inclusion criteria, but not all four criteria for random allocation, will be included in the observational cohort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Line 6"/>
          <p:cNvSpPr/>
          <p:nvPr/>
        </p:nvSpPr>
        <p:spPr>
          <a:xfrm>
            <a:off x="1809720" y="2924280"/>
            <a:ext cx="0" cy="15127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Line 8"/>
          <p:cNvSpPr/>
          <p:nvPr/>
        </p:nvSpPr>
        <p:spPr>
          <a:xfrm>
            <a:off x="1809720" y="3659040"/>
            <a:ext cx="64944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Rectangle 9"/>
          <p:cNvSpPr/>
          <p:nvPr/>
        </p:nvSpPr>
        <p:spPr>
          <a:xfrm>
            <a:off x="457200" y="650880"/>
            <a:ext cx="8640720" cy="2286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Rectangle 10"/>
          <p:cNvSpPr/>
          <p:nvPr/>
        </p:nvSpPr>
        <p:spPr>
          <a:xfrm>
            <a:off x="2486160" y="3213000"/>
            <a:ext cx="6627600" cy="9702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Rectangle 11"/>
          <p:cNvSpPr/>
          <p:nvPr/>
        </p:nvSpPr>
        <p:spPr>
          <a:xfrm>
            <a:off x="457200" y="4479840"/>
            <a:ext cx="8697960" cy="20988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97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5-09-20T07:17:36Z</dcterms:created>
  <dc:creator>Acer</dc:creator>
  <dc:description/>
  <dc:language>en-US</dc:language>
  <cp:lastModifiedBy>Michela Nosè</cp:lastModifiedBy>
  <dcterms:modified xsi:type="dcterms:W3CDTF">2009-05-11T10:31:32Z</dcterms:modified>
  <cp:revision>148</cp:revision>
  <dc:subject/>
  <dc:title>Presentazione di PowerPoint</dc:title>
</cp:coreProperties>
</file>